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7B8227-7DDC-4529-84F9-FE4AFAFC91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CA8C78-F017-4DC4-B118-835A84BB88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960E08-8859-44D8-B609-0C82FE81C8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DBA5C3-1A5C-4A21-9FD0-8AC5F6282B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92154D-3719-4737-AD7E-473280021B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07C95A-7E67-4D5B-BB6E-5CE07577F4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F45271-002E-4901-B62C-2C9D3DB76E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AC56AB-A00A-45F2-8D36-954C230F87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278D32-FC9F-4270-92FF-CE820FD1CE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A1BE6A-AD16-4D99-A9C8-8837BE75EB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E68EA8-6C71-4F0F-B084-883C3CC3E3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B6F90E-F7DC-41D6-A38D-E5A800DBB4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ECA95E-BA43-4FDC-95FD-BA15DD9825AF}" type="slidenum">
              <a:rPr b="0" lang="pl-P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57120" y="660240"/>
          <a:ext cx="8215560" cy="2768760"/>
        </p:xfrm>
        <a:graphic>
          <a:graphicData uri="http://schemas.openxmlformats.org/drawingml/2006/table">
            <a:tbl>
              <a:tblPr/>
              <a:tblGrid>
                <a:gridCol w="1357560"/>
                <a:gridCol w="2357280"/>
                <a:gridCol w="2446200"/>
                <a:gridCol w="2054520"/>
              </a:tblGrid>
              <a:tr h="914400"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rameter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L</a:t>
                      </a: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pl-PL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pl-PL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ales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alue ±SD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R males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alue ±SD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nge of norm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WB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19 x 10 </a:t>
                      </a:r>
                      <a:r>
                        <a:rPr b="0" lang="pl-PL" sz="1400" spc="-1" strike="noStrike" baseline="30000">
                          <a:solidFill>
                            <a:srgbClr val="000000"/>
                          </a:solidFill>
                          <a:latin typeface="Czcionka tekstu podstawowego"/>
                        </a:rPr>
                        <a:t>3</a:t>
                      </a: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± 1,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15,85 x10 </a:t>
                      </a:r>
                      <a:r>
                        <a:rPr b="0" lang="pl-PL" sz="1400" spc="-1" strike="noStrike" baseline="30000">
                          <a:solidFill>
                            <a:srgbClr val="000000"/>
                          </a:solidFill>
                          <a:latin typeface="Czcionka tekstu podstawowego"/>
                        </a:rPr>
                        <a:t>3</a:t>
                      </a: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  ± 3,97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2060"/>
                          </a:solidFill>
                          <a:latin typeface="Czcionka tekstu podstawowego"/>
                        </a:rPr>
                        <a:t>3,0-15 x10 </a:t>
                      </a:r>
                      <a:r>
                        <a:rPr b="1" lang="pl-PL" sz="1400" spc="-1" strike="noStrike" baseline="30000">
                          <a:solidFill>
                            <a:srgbClr val="002060"/>
                          </a:solidFill>
                          <a:latin typeface="Czcionka tekstu podstawowego"/>
                        </a:rPr>
                        <a:t>3</a:t>
                      </a:r>
                      <a:r>
                        <a:rPr b="1" lang="pl-PL" sz="1400" spc="-1" strike="noStrike">
                          <a:solidFill>
                            <a:srgbClr val="002060"/>
                          </a:solidFill>
                          <a:latin typeface="Czcionka tekstu podstawowego"/>
                        </a:rPr>
                        <a:t>/mm</a:t>
                      </a:r>
                      <a:r>
                        <a:rPr b="1" lang="pl-PL" sz="1400" spc="-1" strike="noStrike" baseline="30000">
                          <a:solidFill>
                            <a:srgbClr val="002060"/>
                          </a:solidFill>
                          <a:latin typeface="Czcionka tekstu podstawowego"/>
                        </a:rPr>
                        <a:t>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RB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10,7  x10</a:t>
                      </a:r>
                      <a:r>
                        <a:rPr b="0" lang="pl-PL" sz="1400" spc="-1" strike="noStrike" baseline="30000">
                          <a:solidFill>
                            <a:srgbClr val="000000"/>
                          </a:solidFill>
                          <a:latin typeface="Czcionka tekstu podstawowego"/>
                        </a:rPr>
                        <a:t>6</a:t>
                      </a: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± 0,54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10,95 x10</a:t>
                      </a:r>
                      <a:r>
                        <a:rPr b="0" lang="pl-PL" sz="1400" spc="-1" strike="noStrike" baseline="30000">
                          <a:solidFill>
                            <a:srgbClr val="000000"/>
                          </a:solidFill>
                          <a:latin typeface="Czcionka tekstu podstawowego"/>
                        </a:rPr>
                        <a:t>6</a:t>
                      </a: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 ± 0,27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2060"/>
                          </a:solidFill>
                          <a:latin typeface="Czcionka tekstu podstawowego"/>
                        </a:rPr>
                        <a:t>7,14-12,2 x 10</a:t>
                      </a:r>
                      <a:r>
                        <a:rPr b="1" lang="pl-PL" sz="1400" spc="-1" strike="noStrike" baseline="30000">
                          <a:solidFill>
                            <a:srgbClr val="002060"/>
                          </a:solidFill>
                          <a:latin typeface="Czcionka tekstu podstawowego"/>
                        </a:rPr>
                        <a:t>6</a:t>
                      </a:r>
                      <a:r>
                        <a:rPr b="1" lang="pl-PL" sz="1400" spc="-1" strike="noStrike">
                          <a:solidFill>
                            <a:srgbClr val="002060"/>
                          </a:solidFill>
                          <a:latin typeface="Czcionka tekstu podstawowego"/>
                        </a:rPr>
                        <a:t>/mm</a:t>
                      </a:r>
                      <a:r>
                        <a:rPr b="1" lang="pl-PL" sz="1400" spc="-1" strike="noStrike" baseline="30000">
                          <a:solidFill>
                            <a:srgbClr val="002060"/>
                          </a:solidFill>
                          <a:latin typeface="Czcionka tekstu podstawowego"/>
                        </a:rPr>
                        <a:t>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HGB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16,41 g ±0,33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17,25 g  ± 0,43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2060"/>
                          </a:solidFill>
                          <a:latin typeface="Czcionka tekstu podstawowego"/>
                        </a:rPr>
                        <a:t>10,8-19,2 g/d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HC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50,01 %  ± 1,31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53,567 % ± 2,08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2060"/>
                          </a:solidFill>
                          <a:latin typeface="Czcionka tekstu podstawowego"/>
                        </a:rPr>
                        <a:t>37,3-62,0 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PL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160,5 x10 </a:t>
                      </a:r>
                      <a:r>
                        <a:rPr b="0" lang="pl-PL" sz="1400" spc="-1" strike="noStrike" baseline="30000">
                          <a:solidFill>
                            <a:srgbClr val="000000"/>
                          </a:solidFill>
                          <a:latin typeface="Czcionka tekstu podstawowego"/>
                        </a:rPr>
                        <a:t>3</a:t>
                      </a: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 ± 82,77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108,75  x10 </a:t>
                      </a:r>
                      <a:r>
                        <a:rPr b="0" lang="pl-PL" sz="1400" spc="-1" strike="noStrike" baseline="30000">
                          <a:solidFill>
                            <a:srgbClr val="000000"/>
                          </a:solidFill>
                          <a:latin typeface="Czcionka tekstu podstawowego"/>
                        </a:rPr>
                        <a:t>3</a:t>
                      </a: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 ± 25,47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2060"/>
                          </a:solidFill>
                          <a:latin typeface="Czcionka tekstu podstawowego"/>
                        </a:rPr>
                        <a:t>140-600 x10</a:t>
                      </a:r>
                      <a:r>
                        <a:rPr b="1" lang="pl-PL" sz="1400" spc="-1" strike="noStrike" baseline="30000">
                          <a:solidFill>
                            <a:srgbClr val="002060"/>
                          </a:solidFill>
                          <a:latin typeface="Czcionka tekstu podstawowego"/>
                        </a:rPr>
                        <a:t>3</a:t>
                      </a:r>
                      <a:r>
                        <a:rPr b="1" lang="pl-PL" sz="1400" spc="-1" strike="noStrike">
                          <a:solidFill>
                            <a:srgbClr val="002060"/>
                          </a:solidFill>
                          <a:latin typeface="Czcionka tekstu podstawowego"/>
                        </a:rPr>
                        <a:t>/mm</a:t>
                      </a:r>
                      <a:r>
                        <a:rPr b="1" lang="pl-PL" sz="1400" spc="-1" strike="noStrike" baseline="30000">
                          <a:solidFill>
                            <a:srgbClr val="002060"/>
                          </a:solidFill>
                          <a:latin typeface="Czcionka tekstu podstawowego"/>
                        </a:rPr>
                        <a:t>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357120" y="3573360"/>
          <a:ext cx="8215560" cy="2768760"/>
        </p:xfrm>
        <a:graphic>
          <a:graphicData uri="http://schemas.openxmlformats.org/drawingml/2006/table">
            <a:tbl>
              <a:tblPr/>
              <a:tblGrid>
                <a:gridCol w="1357560"/>
                <a:gridCol w="2357280"/>
                <a:gridCol w="2446200"/>
                <a:gridCol w="2054520"/>
              </a:tblGrid>
              <a:tr h="914400"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rameter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L</a:t>
                      </a: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pl-PL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Females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alue ±SD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R females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alue ±SD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nge of norm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WB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14,7 x10 </a:t>
                      </a:r>
                      <a:r>
                        <a:rPr b="0" lang="pl-PL" sz="1400" spc="-1" strike="noStrike" baseline="30000">
                          <a:solidFill>
                            <a:srgbClr val="000000"/>
                          </a:solidFill>
                          <a:latin typeface="Czcionka tekstu podstawowego"/>
                        </a:rPr>
                        <a:t>3</a:t>
                      </a: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 ± 3,7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16,3x10 </a:t>
                      </a:r>
                      <a:r>
                        <a:rPr b="0" lang="pl-PL" sz="1400" spc="-1" strike="noStrike" baseline="30000">
                          <a:solidFill>
                            <a:srgbClr val="000000"/>
                          </a:solidFill>
                          <a:latin typeface="Czcionka tekstu podstawowego"/>
                        </a:rPr>
                        <a:t>3</a:t>
                      </a: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 ± 2,3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2060"/>
                          </a:solidFill>
                          <a:latin typeface="Czcionka tekstu podstawowego"/>
                        </a:rPr>
                        <a:t>3,0-15 x10 </a:t>
                      </a:r>
                      <a:r>
                        <a:rPr b="1" lang="pl-PL" sz="1400" spc="-1" strike="noStrike" baseline="30000">
                          <a:solidFill>
                            <a:srgbClr val="002060"/>
                          </a:solidFill>
                          <a:latin typeface="Czcionka tekstu podstawowego"/>
                        </a:rPr>
                        <a:t>3</a:t>
                      </a:r>
                      <a:r>
                        <a:rPr b="1" lang="pl-PL" sz="1400" spc="-1" strike="noStrike">
                          <a:solidFill>
                            <a:srgbClr val="002060"/>
                          </a:solidFill>
                          <a:latin typeface="Czcionka tekstu podstawowego"/>
                        </a:rPr>
                        <a:t>/mm</a:t>
                      </a:r>
                      <a:r>
                        <a:rPr b="1" lang="pl-PL" sz="1400" spc="-1" strike="noStrike" baseline="30000">
                          <a:solidFill>
                            <a:srgbClr val="002060"/>
                          </a:solidFill>
                          <a:latin typeface="Czcionka tekstu podstawowego"/>
                        </a:rPr>
                        <a:t>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RB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9,7 x10</a:t>
                      </a:r>
                      <a:r>
                        <a:rPr b="0" lang="pl-PL" sz="1400" spc="-1" strike="noStrike" baseline="30000">
                          <a:solidFill>
                            <a:srgbClr val="000000"/>
                          </a:solidFill>
                          <a:latin typeface="Czcionka tekstu podstawowego"/>
                        </a:rPr>
                        <a:t>6</a:t>
                      </a: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± 2,5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10,28 x10</a:t>
                      </a:r>
                      <a:r>
                        <a:rPr b="0" lang="pl-PL" sz="1400" spc="-1" strike="noStrike" baseline="30000">
                          <a:solidFill>
                            <a:srgbClr val="000000"/>
                          </a:solidFill>
                          <a:latin typeface="Czcionka tekstu podstawowego"/>
                        </a:rPr>
                        <a:t>6</a:t>
                      </a: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± 0,4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2060"/>
                          </a:solidFill>
                          <a:latin typeface="Czcionka tekstu podstawowego"/>
                        </a:rPr>
                        <a:t>7,14-12,2 x 10</a:t>
                      </a:r>
                      <a:r>
                        <a:rPr b="1" lang="pl-PL" sz="1400" spc="-1" strike="noStrike" baseline="30000">
                          <a:solidFill>
                            <a:srgbClr val="002060"/>
                          </a:solidFill>
                          <a:latin typeface="Czcionka tekstu podstawowego"/>
                        </a:rPr>
                        <a:t>6</a:t>
                      </a:r>
                      <a:r>
                        <a:rPr b="1" lang="pl-PL" sz="1400" spc="-1" strike="noStrike">
                          <a:solidFill>
                            <a:srgbClr val="002060"/>
                          </a:solidFill>
                          <a:latin typeface="Czcionka tekstu podstawowego"/>
                        </a:rPr>
                        <a:t>/mm</a:t>
                      </a:r>
                      <a:r>
                        <a:rPr b="1" lang="pl-PL" sz="1400" spc="-1" strike="noStrike" baseline="30000">
                          <a:solidFill>
                            <a:srgbClr val="002060"/>
                          </a:solidFill>
                          <a:latin typeface="Czcionka tekstu podstawowego"/>
                        </a:rPr>
                        <a:t>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HGB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15,033 g± 3,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16,23 g± 0,4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2060"/>
                          </a:solidFill>
                          <a:latin typeface="Czcionka tekstu podstawowego"/>
                        </a:rPr>
                        <a:t>10,8-19,2 g/d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HC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45,45 %± 9,9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50,5% ±1,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2060"/>
                          </a:solidFill>
                          <a:latin typeface="Czcionka tekstu podstawowego"/>
                        </a:rPr>
                        <a:t>37,3-62,0 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PL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258,75  x10 </a:t>
                      </a:r>
                      <a:r>
                        <a:rPr b="0" lang="pl-PL" sz="1400" spc="-1" strike="noStrike" baseline="30000">
                          <a:solidFill>
                            <a:srgbClr val="000000"/>
                          </a:solidFill>
                          <a:latin typeface="Czcionka tekstu podstawowego"/>
                        </a:rPr>
                        <a:t>3</a:t>
                      </a: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± 75,4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188,2 x10 </a:t>
                      </a:r>
                      <a:r>
                        <a:rPr b="0" lang="pl-PL" sz="1400" spc="-1" strike="noStrike" baseline="30000">
                          <a:solidFill>
                            <a:srgbClr val="000000"/>
                          </a:solidFill>
                          <a:latin typeface="Czcionka tekstu podstawowego"/>
                        </a:rPr>
                        <a:t>3</a:t>
                      </a:r>
                      <a:r>
                        <a:rPr b="0" lang="pl-PL" sz="1400" spc="-1" strike="noStrike">
                          <a:solidFill>
                            <a:srgbClr val="000000"/>
                          </a:solidFill>
                          <a:latin typeface="Czcionka tekstu podstawowego"/>
                        </a:rPr>
                        <a:t> ±78,8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1400" spc="-1" strike="noStrike">
                          <a:solidFill>
                            <a:srgbClr val="002060"/>
                          </a:solidFill>
                          <a:latin typeface="Czcionka tekstu podstawowego"/>
                        </a:rPr>
                        <a:t>140-600 x10</a:t>
                      </a:r>
                      <a:r>
                        <a:rPr b="1" lang="pl-PL" sz="1400" spc="-1" strike="noStrike" baseline="30000">
                          <a:solidFill>
                            <a:srgbClr val="002060"/>
                          </a:solidFill>
                          <a:latin typeface="Czcionka tekstu podstawowego"/>
                        </a:rPr>
                        <a:t>3</a:t>
                      </a:r>
                      <a:r>
                        <a:rPr b="1" lang="pl-PL" sz="1400" spc="-1" strike="noStrike">
                          <a:solidFill>
                            <a:srgbClr val="002060"/>
                          </a:solidFill>
                          <a:latin typeface="Czcionka tekstu podstawowego"/>
                        </a:rPr>
                        <a:t>/mm</a:t>
                      </a:r>
                      <a:r>
                        <a:rPr b="1" lang="pl-PL" sz="1400" spc="-1" strike="noStrike" baseline="30000">
                          <a:solidFill>
                            <a:srgbClr val="002060"/>
                          </a:solidFill>
                          <a:latin typeface="Czcionka tekstu podstawowego"/>
                        </a:rPr>
                        <a:t>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TextBox 1"/>
          <p:cNvSpPr/>
          <p:nvPr/>
        </p:nvSpPr>
        <p:spPr>
          <a:xfrm>
            <a:off x="395280" y="189000"/>
            <a:ext cx="7993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Peripheral  blood counts in male and female mice at AL and CR die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11"/>
          <p:cNvSpPr/>
          <p:nvPr/>
        </p:nvSpPr>
        <p:spPr>
          <a:xfrm>
            <a:off x="5580000" y="6453360"/>
            <a:ext cx="316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          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6-03T06:23:49Z</dcterms:created>
  <dc:creator>pum</dc:creator>
  <dc:description/>
  <dc:language>en-US</dc:language>
  <cp:lastModifiedBy>Mariusz Ratajczak</cp:lastModifiedBy>
  <dcterms:modified xsi:type="dcterms:W3CDTF">2014-06-08T20:18:38Z</dcterms:modified>
  <cp:revision>5</cp:revision>
  <dc:subject/>
  <dc:title>Slajd 1</dc:title>
</cp:coreProperties>
</file>